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90" d="100"/>
          <a:sy n="90" d="100"/>
        </p:scale>
        <p:origin x="124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0" cy="720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59ED7-517C-4638-BA08-6BAB7A2F78D4}" type="datetimeFigureOut">
              <a:rPr kumimoji="1" lang="ja-JP" altLang="en-US" smtClean="0"/>
              <a:t>2017/7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DE6ED6-1C04-4F97-86FF-CA18743245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99109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59ED7-517C-4638-BA08-6BAB7A2F78D4}" type="datetimeFigureOut">
              <a:rPr kumimoji="1" lang="ja-JP" altLang="en-US" smtClean="0"/>
              <a:t>2017/7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DE6ED6-1C04-4F97-86FF-CA18743245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30348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59ED7-517C-4638-BA08-6BAB7A2F78D4}" type="datetimeFigureOut">
              <a:rPr kumimoji="1" lang="ja-JP" altLang="en-US" smtClean="0"/>
              <a:t>2017/7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DE6ED6-1C04-4F97-86FF-CA18743245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7828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59ED7-517C-4638-BA08-6BAB7A2F78D4}" type="datetimeFigureOut">
              <a:rPr kumimoji="1" lang="ja-JP" altLang="en-US" smtClean="0"/>
              <a:t>2017/7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DE6ED6-1C04-4F97-86FF-CA18743245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34978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59ED7-517C-4638-BA08-6BAB7A2F78D4}" type="datetimeFigureOut">
              <a:rPr kumimoji="1" lang="ja-JP" altLang="en-US" smtClean="0"/>
              <a:t>2017/7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DE6ED6-1C04-4F97-86FF-CA18743245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55346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59ED7-517C-4638-BA08-6BAB7A2F78D4}" type="datetimeFigureOut">
              <a:rPr kumimoji="1" lang="ja-JP" altLang="en-US" smtClean="0"/>
              <a:t>2017/7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DE6ED6-1C04-4F97-86FF-CA18743245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18718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59ED7-517C-4638-BA08-6BAB7A2F78D4}" type="datetimeFigureOut">
              <a:rPr kumimoji="1" lang="ja-JP" altLang="en-US" smtClean="0"/>
              <a:t>2017/7/2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DE6ED6-1C04-4F97-86FF-CA18743245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91953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59ED7-517C-4638-BA08-6BAB7A2F78D4}" type="datetimeFigureOut">
              <a:rPr kumimoji="1" lang="ja-JP" altLang="en-US" smtClean="0"/>
              <a:t>2017/7/2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DE6ED6-1C04-4F97-86FF-CA18743245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43982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59ED7-517C-4638-BA08-6BAB7A2F78D4}" type="datetimeFigureOut">
              <a:rPr kumimoji="1" lang="ja-JP" altLang="en-US" smtClean="0"/>
              <a:t>2017/7/2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DE6ED6-1C04-4F97-86FF-CA18743245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09265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59ED7-517C-4638-BA08-6BAB7A2F78D4}" type="datetimeFigureOut">
              <a:rPr kumimoji="1" lang="ja-JP" altLang="en-US" smtClean="0"/>
              <a:t>2017/7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DE6ED6-1C04-4F97-86FF-CA18743245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96205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59ED7-517C-4638-BA08-6BAB7A2F78D4}" type="datetimeFigureOut">
              <a:rPr kumimoji="1" lang="ja-JP" altLang="en-US" smtClean="0"/>
              <a:t>2017/7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DE6ED6-1C04-4F97-86FF-CA18743245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27974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759ED7-517C-4638-BA08-6BAB7A2F78D4}" type="datetimeFigureOut">
              <a:rPr kumimoji="1" lang="ja-JP" altLang="en-US" smtClean="0"/>
              <a:t>2017/7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DE6ED6-1C04-4F97-86FF-CA18743245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85218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196480" y="378136"/>
            <a:ext cx="26813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Table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正方形/長方形 6"/>
          <p:cNvSpPr/>
          <p:nvPr/>
        </p:nvSpPr>
        <p:spPr>
          <a:xfrm>
            <a:off x="132684" y="1324328"/>
            <a:ext cx="453290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b="0" i="0" u="none" strike="noStrike" baseline="0" dirty="0" smtClean="0">
                <a:solidFill>
                  <a:srgbClr val="000000"/>
                </a:solidFill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Targeted 166</a:t>
            </a:r>
            <a:r>
              <a:rPr lang="ja-JP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genes</a:t>
            </a:r>
            <a:r>
              <a:rPr lang="ja-JP" altLang="en-US" sz="1200" b="0" i="0" u="none" strike="noStrike" baseline="0" dirty="0" smtClean="0">
                <a:solidFill>
                  <a:srgbClr val="000000"/>
                </a:solidFill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 </a:t>
            </a:r>
            <a:r>
              <a:rPr lang="en-US" altLang="ja-JP" sz="1200" b="0" i="0" u="none" strike="noStrike" baseline="0" dirty="0" smtClean="0">
                <a:solidFill>
                  <a:srgbClr val="000000"/>
                </a:solidFill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in the present analysi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s </a:t>
            </a:r>
            <a:r>
              <a:rPr lang="en-US" altLang="ja-JP" sz="1200" b="0" i="0" u="none" strike="noStrike" baseline="0" dirty="0" smtClean="0">
                <a:solidFill>
                  <a:srgbClr val="000000"/>
                </a:solidFill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(SPEEDI-KID version 3.0) 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9" name="表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33690774"/>
              </p:ext>
            </p:extLst>
          </p:nvPr>
        </p:nvGraphicFramePr>
        <p:xfrm>
          <a:off x="196480" y="1698756"/>
          <a:ext cx="6480000" cy="334075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48000"/>
                <a:gridCol w="648000"/>
                <a:gridCol w="648000"/>
                <a:gridCol w="648000"/>
                <a:gridCol w="648000"/>
                <a:gridCol w="648000"/>
                <a:gridCol w="648000"/>
                <a:gridCol w="648000"/>
                <a:gridCol w="648000"/>
                <a:gridCol w="648000"/>
              </a:tblGrid>
              <a:tr h="19651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CG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N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AMTS1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TR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X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L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OS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OA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O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  <a:tr h="1965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OL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R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QP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HGAP2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HGDI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P6V0A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P6V0A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P6V1B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P7B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PR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</a:tr>
              <a:tr h="1965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SND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CNA1D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CNA1H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R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2AP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C7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KN1B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</a:tr>
              <a:tr h="1965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FB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FH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FHR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FHR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FHR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F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CN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CNK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CNKB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DN1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</a:tr>
              <a:tr h="1965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DN1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NNM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L4A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L4A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L4A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L4A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L5A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L5A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Q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Q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</a:tr>
              <a:tr h="1965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Q8B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B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N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B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L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P11B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P11B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P27B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GK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MP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</a:tr>
              <a:tr h="1965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GF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HHADH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PP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YA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BN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GF2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GFR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KBP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N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XYD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</a:tr>
              <a:tr h="1965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6PC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TA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M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NA1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NA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NAS-AS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PIHBP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HP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NF1B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</a:tr>
              <a:tr h="1965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NF4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OGA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PRT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D11B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F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TGA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TGB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CNA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CNJ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CNJ1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</a:tr>
              <a:tr h="1965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CNJ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LHL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LHL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MB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MX1B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PL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F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N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C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H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</a:tr>
              <a:tr h="1965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O1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DD4L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LRP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HS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HS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R3C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CRL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XSR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X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DSS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</a:tr>
              <a:tr h="1965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EX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KD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KD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KHD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CE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G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K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KR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TH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TPR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</a:tr>
              <a:tr h="1965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LL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RS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N1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N1B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NN1G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GK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X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X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</a:tr>
              <a:tr h="1965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C12A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C12A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C16A1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C17A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C22A1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C2A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C2A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C34A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C34A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C3A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</a:tr>
              <a:tr h="1965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C4A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C4A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C5A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C5A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C7A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C9A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MARCAL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QSTM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K3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X1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</a:tr>
              <a:tr h="1965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BD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NXB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PC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PM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SC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SC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MOD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D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HL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NK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noFill/>
                  </a:tcPr>
                </a:tc>
              </a:tr>
              <a:tr h="1965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NK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NK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NK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DH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Whole </a:t>
                      </a:r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tochondrial gen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161" marR="6161" marT="6161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406282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1</TotalTime>
  <Words>183</Words>
  <Application>Microsoft Office PowerPoint</Application>
  <PresentationFormat>A4 210 x 297 mm</PresentationFormat>
  <Paragraphs>16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ＭＳ Ｐゴシック</vt:lpstr>
      <vt:lpstr>ＭＳ 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Eikan Mishima</dc:creator>
  <cp:lastModifiedBy>Eikan Mishima</cp:lastModifiedBy>
  <cp:revision>6</cp:revision>
  <dcterms:created xsi:type="dcterms:W3CDTF">2017-07-20T02:24:29Z</dcterms:created>
  <dcterms:modified xsi:type="dcterms:W3CDTF">2017-07-20T09:27:16Z</dcterms:modified>
</cp:coreProperties>
</file>